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8F7BC-2885-476A-976E-D2059C208C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0EE6D6-A08F-4CED-8490-FEC0EAFE26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822C0B-413F-49E5-BF5C-2875C739F6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EDF65E-A3CE-40D2-BF41-1DBD98540E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2BF2C-CC59-4346-9A2A-2C0E2D29DF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EE6B3-D387-40BF-9EF8-80C871D4FA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93C62-5343-4C39-AA76-09A96A7177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C0A959-5650-403F-B60B-8A4D29E961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9CD52-C7F4-4CC6-A170-ABB7DFED1D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2BF34-39D6-4A2E-8B9B-9AA2769513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6E3DD-9CAD-44DD-89F3-87EDFC4966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AEDE5-0D83-4A70-95DB-5FAAEA6580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4F4F40-2754-4D0E-8501-61DA0032219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3"/>
          <p:cNvSpPr/>
          <p:nvPr/>
        </p:nvSpPr>
        <p:spPr>
          <a:xfrm>
            <a:off x="250920" y="189000"/>
            <a:ext cx="8497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 S4.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imers used in the quantitative real time PC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403280" y="620640"/>
          <a:ext cx="6624720" cy="5857920"/>
        </p:xfrm>
        <a:graphic>
          <a:graphicData uri="http://schemas.openxmlformats.org/drawingml/2006/table">
            <a:tbl>
              <a:tblPr/>
              <a:tblGrid>
                <a:gridCol w="1079640"/>
                <a:gridCol w="1728720"/>
                <a:gridCol w="1008000"/>
                <a:gridCol w="2808360"/>
              </a:tblGrid>
              <a:tr h="360360">
                <a:tc>
                  <a:txBody>
                    <a:bodyPr lIns="26280" rIns="2628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Gene symbo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Bank accession no.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s of prim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432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G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M_0019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CCGCATGTAACCCGGCCAGG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GCCATCCTGGACGAGCAGGC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B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027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TGCTGAACTCCGCTGCATGTGT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TGGTTGCAATGGGTTCCTTTCCCG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LF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042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CAAGGCACACCTGCGAACCCA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GCGGGCGAATTTCCATCCACA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AS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168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TCCACCTGCTTCACAGAACTACA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TGGGCTGTGTTGAAATGTGTTT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2RY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1768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TGGCACCCTGGCAGCTCAGA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AGCCCTAACAGCACGATGCCC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CAM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010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-GCCCACAGTAAGGCAGGCTGT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-GCCACCTTCTTGCAGCTTTGTGG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NFRSF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015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AACGTGGCATCTGTCGACCCT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CCACAGACCACGTCCCTCTCCT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PR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2015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GCACATCCACTCCCGGCAGG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'-CGCTCCGGCCTTTCGTCCTC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P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020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GATTCCACCCATGGCAAATTCCA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TGGTGATGGGATTTCCATTGATGA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XCL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220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GATGCTCCTGTCCACCTTGC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CGGCTGCTTCTGGTTCTCC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L13R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015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CGGAAACTCGTCGTTCAATAGAAG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GCTCAGGTTGTGCCAAATGC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R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055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TGAGAAGAAGAACAAGGCGGTGAAG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TGATGGGATTAAGGCAGCAGTGAAC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FNG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055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CCGCCAGACCCTCTTTCC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GCCTCGTGCTATTGCTCAG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D40L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000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AGCCAGCCTCTGCCTAAAG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CACATTGACAAACACCGAAGC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X3C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NM_0013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CTTCATCACCGTCATCAG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0" bIns="0" anchor="ctr">
                      <a:noAutofit/>
                    </a:bodyPr>
                    <a:p>
                      <a:pPr marL="179280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5’-GTAGTCACCAAGGCATTC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Box 5"/>
          <p:cNvSpPr/>
          <p:nvPr/>
        </p:nvSpPr>
        <p:spPr>
          <a:xfrm>
            <a:off x="1403280" y="6453360"/>
            <a:ext cx="2089080" cy="30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1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, forward; R, rever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0T02:50:44Z</dcterms:created>
  <dc:creator>MIT, Faculty of Medicine</dc:creator>
  <dc:description/>
  <dc:language>en-US</dc:language>
  <cp:lastModifiedBy>MIT, Faculty of Medicine</cp:lastModifiedBy>
  <dcterms:modified xsi:type="dcterms:W3CDTF">2012-07-18T09:01:49Z</dcterms:modified>
  <cp:revision>3</cp:revision>
  <dc:subject/>
  <dc:title>幻灯片 1</dc:title>
</cp:coreProperties>
</file>